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54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1700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707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2354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696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29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464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59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5256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314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224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455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31AA1-E338-4CB5-87EF-52D35B409302}" type="datetimeFigureOut">
              <a:rPr lang="en-US" smtClean="0"/>
              <a:t>4/4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27D5F-3F96-4C25-9870-3340C9FC8F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122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Worksheet1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189507"/>
              </p:ext>
            </p:extLst>
          </p:nvPr>
        </p:nvGraphicFramePr>
        <p:xfrm>
          <a:off x="228600" y="1219200"/>
          <a:ext cx="7881938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Worksheet" r:id="rId4" imgW="7410602" imgH="2724302" progId="Excel.Sheet.12">
                  <p:embed/>
                </p:oleObj>
              </mc:Choice>
              <mc:Fallback>
                <p:oleObj name="Worksheet" r:id="rId4" imgW="7410602" imgH="2724302" progId="Excel.Sheet.12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8600" y="1219200"/>
                        <a:ext cx="7881938" cy="3048000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ctangle 5"/>
          <p:cNvSpPr>
            <a:spLocks noChangeArrowheads="1"/>
          </p:cNvSpPr>
          <p:nvPr/>
        </p:nvSpPr>
        <p:spPr bwMode="auto">
          <a:xfrm>
            <a:off x="6927" y="4495800"/>
            <a:ext cx="8686800" cy="6001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 </a:t>
            </a:r>
            <a:r>
              <a: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PCR Primers for Methylation Detection of the Promoter and First Exon region of FABP3. *Forward Primers contain the T7 promoter tag (5’ AGG AAG AGA G 3’) on the 5’ end of the primer sequence, **Reverse primers contain the T7-promoter tag (5’ CAG TAA TAC GAC TCA CTA TAG GGA GAA GGC T 3’) on the 5’ end of the primer sequence. Primers are complementary to the reverse (-) template strand. 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09600" y="228600"/>
            <a:ext cx="320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Tabl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7382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Worksheet</vt:lpstr>
      <vt:lpstr>PowerPoint Presentation</vt:lpstr>
    </vt:vector>
  </TitlesOfParts>
  <Company>MCW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rjak, Diana</dc:creator>
  <cp:lastModifiedBy>Cerjak, Diana</cp:lastModifiedBy>
  <cp:revision>1</cp:revision>
  <dcterms:created xsi:type="dcterms:W3CDTF">2012-04-04T14:53:00Z</dcterms:created>
  <dcterms:modified xsi:type="dcterms:W3CDTF">2012-04-04T14:53:27Z</dcterms:modified>
</cp:coreProperties>
</file>